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2DE63D5-997A-4646-A377-4702673A728D}" styleName="Estilo claro 2 - Acento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318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7753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6958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6942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7864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8765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7558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070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2083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1310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1354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46005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3CCC5-6426-4E6C-B348-B2ED1E5C3D38}" type="datetimeFigureOut">
              <a:rPr lang="es-ES" smtClean="0"/>
              <a:t>23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02E198-D7AF-4924-87A0-C55AFEE3D8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1028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4 CuadroTexto">
            <a:extLst>
              <a:ext uri="{FF2B5EF4-FFF2-40B4-BE49-F238E27FC236}">
                <a16:creationId xmlns:a16="http://schemas.microsoft.com/office/drawing/2014/main" id="{A2CB067B-8FB3-9B6A-ACEC-AD4738FE2715}"/>
              </a:ext>
            </a:extLst>
          </p:cNvPr>
          <p:cNvSpPr txBox="1"/>
          <p:nvPr/>
        </p:nvSpPr>
        <p:spPr>
          <a:xfrm>
            <a:off x="73152" y="391729"/>
            <a:ext cx="4058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 Table 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. </a:t>
            </a:r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ers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aphicFrame>
        <p:nvGraphicFramePr>
          <p:cNvPr id="5" name="Tabla 4">
            <a:extLst>
              <a:ext uri="{FF2B5EF4-FFF2-40B4-BE49-F238E27FC236}">
                <a16:creationId xmlns:a16="http://schemas.microsoft.com/office/drawing/2014/main" id="{AA70FF93-0955-5C1F-C4D0-AA59D8765B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921514"/>
              </p:ext>
            </p:extLst>
          </p:nvPr>
        </p:nvGraphicFramePr>
        <p:xfrm>
          <a:off x="621926" y="977860"/>
          <a:ext cx="5192819" cy="6278880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1257674">
                  <a:extLst>
                    <a:ext uri="{9D8B030D-6E8A-4147-A177-3AD203B41FA5}">
                      <a16:colId xmlns:a16="http://schemas.microsoft.com/office/drawing/2014/main" val="311987513"/>
                    </a:ext>
                  </a:extLst>
                </a:gridCol>
                <a:gridCol w="2457450">
                  <a:extLst>
                    <a:ext uri="{9D8B030D-6E8A-4147-A177-3AD203B41FA5}">
                      <a16:colId xmlns:a16="http://schemas.microsoft.com/office/drawing/2014/main" val="3453939031"/>
                    </a:ext>
                  </a:extLst>
                </a:gridCol>
                <a:gridCol w="1477695">
                  <a:extLst>
                    <a:ext uri="{9D8B030D-6E8A-4147-A177-3AD203B41FA5}">
                      <a16:colId xmlns:a16="http://schemas.microsoft.com/office/drawing/2014/main" val="80320375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4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es-ES" sz="14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r>
                        <a:rPr lang="es-E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5’ </a:t>
                      </a:r>
                      <a:r>
                        <a:rPr lang="es-E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Wingdings" panose="05000000000000000000" pitchFamily="2" charset="2"/>
                        </a:rPr>
                        <a:t> 3’</a:t>
                      </a:r>
                      <a:endParaRPr lang="es-ES" sz="14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plication</a:t>
                      </a:r>
                      <a:endParaRPr lang="es-ES" sz="14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62650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i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tert</a:t>
                      </a:r>
                      <a:r>
                        <a:rPr lang="es-ES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t</a:t>
                      </a:r>
                      <a:endParaRPr lang="es-E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CCGGAGGTCTTGGCG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typing</a:t>
                      </a:r>
                      <a:endParaRPr lang="es-E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22053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i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tert</a:t>
                      </a:r>
                      <a:r>
                        <a:rPr lang="es-ES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wt</a:t>
                      </a:r>
                      <a:endParaRPr lang="es-E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CACACCTGCAGAAC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typing</a:t>
                      </a:r>
                      <a:endParaRPr lang="es-E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77424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i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tert</a:t>
                      </a:r>
                      <a:r>
                        <a:rPr lang="es-ES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ut</a:t>
                      </a:r>
                      <a:endParaRPr lang="es-E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CACACCTGCAGAAC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typing</a:t>
                      </a:r>
                      <a:endParaRPr lang="es-E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39975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tert</a:t>
                      </a:r>
                      <a:r>
                        <a:rPr lang="es-E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Fw</a:t>
                      </a:r>
                      <a:endParaRPr lang="es-E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TATGACGGCCTATCAC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RNA</a:t>
                      </a:r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es-E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50197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tert</a:t>
                      </a:r>
                      <a:r>
                        <a:rPr lang="es-E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Rv</a:t>
                      </a:r>
                      <a:endParaRPr lang="es-E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AACGGCCTCCACAGAGT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NA</a:t>
                      </a:r>
                      <a:r>
                        <a:rPr kumimoji="0" lang="es-E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evel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32566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p53</a:t>
                      </a:r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Fw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GGTGAAGGACGAAGG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1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NA</a:t>
                      </a:r>
                      <a:r>
                        <a: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level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88431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p53</a:t>
                      </a:r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Rv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TGACCCCTGTGACAAG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NA</a:t>
                      </a:r>
                      <a:r>
                        <a:rPr kumimoji="0" lang="es-E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evel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78339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p21</a:t>
                      </a:r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Fw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CGCTGCTACGAGACGAA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1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NA</a:t>
                      </a:r>
                      <a:r>
                        <a: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level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86705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p21</a:t>
                      </a:r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Rv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CAAACAGACCAACATCA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1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NA</a:t>
                      </a:r>
                      <a:r>
                        <a: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level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80456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bcl2</a:t>
                      </a:r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Fw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TTACGGGATGCTGGAGA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1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NA</a:t>
                      </a:r>
                      <a:r>
                        <a: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level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51487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bcl2</a:t>
                      </a:r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Rv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CCACCAAACTCGAAG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1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NA</a:t>
                      </a:r>
                      <a:r>
                        <a: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level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83946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rps11</a:t>
                      </a:r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Fw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GAAATGCCCCTTCACT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NA</a:t>
                      </a:r>
                      <a:r>
                        <a:rPr kumimoji="0" lang="es-E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evel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elomere</a:t>
                      </a:r>
                      <a:r>
                        <a:rPr kumimoji="0" lang="es-E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ntent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19131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_rps11</a:t>
                      </a:r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Rv</a:t>
                      </a:r>
                    </a:p>
                    <a:p>
                      <a:pPr algn="ctr"/>
                      <a:endParaRPr lang="es-E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TCTTCTCAAAACGGTT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NA</a:t>
                      </a:r>
                      <a:r>
                        <a:rPr kumimoji="0" lang="es-E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evel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elomere</a:t>
                      </a:r>
                      <a:r>
                        <a:rPr kumimoji="0" lang="es-E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ntent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18270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lom</a:t>
                      </a:r>
                      <a:r>
                        <a:rPr lang="es-E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Fw</a:t>
                      </a:r>
                      <a:endParaRPr lang="es-E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TTTTGAGGGTGAGGGTGAGGGTGAGGGTGAGGG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elomere</a:t>
                      </a:r>
                      <a:r>
                        <a:rPr kumimoji="0" lang="es-E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ntent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93419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lom</a:t>
                      </a:r>
                      <a:r>
                        <a:rPr lang="es-E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Rv</a:t>
                      </a:r>
                      <a:endParaRPr lang="es-E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CGAACTATCCCTATCCCTATCCCTATCCCTATCCCT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elomere</a:t>
                      </a:r>
                      <a:r>
                        <a:rPr kumimoji="0" lang="es-E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0" lang="es-E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ntent</a:t>
                      </a:r>
                      <a:endParaRPr kumimoji="0" lang="es-E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33798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455489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437</TotalTime>
  <Words>105</Words>
  <Application>Microsoft Office PowerPoint</Application>
  <PresentationFormat>Presentación en pantalla (4:3)</PresentationFormat>
  <Paragraphs>5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RANCISCA ALCARAZ PEREZ</dc:creator>
  <cp:lastModifiedBy>FRANCISCA ALCARAZ PEREZ</cp:lastModifiedBy>
  <cp:revision>3</cp:revision>
  <dcterms:created xsi:type="dcterms:W3CDTF">2023-11-15T12:13:19Z</dcterms:created>
  <dcterms:modified xsi:type="dcterms:W3CDTF">2024-10-23T13:38:27Z</dcterms:modified>
</cp:coreProperties>
</file>